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</p:sldIdLst>
  <p:sldSz cx="9144000" cy="6858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5853"/>
  </p:normalViewPr>
  <p:slideViewPr>
    <p:cSldViewPr snapToGrid="0" snapToObjects="1">
      <p:cViewPr>
        <p:scale>
          <a:sx n="106" d="100"/>
          <a:sy n="106" d="100"/>
        </p:scale>
        <p:origin x="1168" y="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D12A3-7B8D-7D43-87BF-A776121F7C54}" type="datetimeFigureOut">
              <a:rPr lang="en-US" smtClean="0"/>
              <a:t>10/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0510F-DB1F-E74A-8057-345FCD244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48222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D12A3-7B8D-7D43-87BF-A776121F7C54}" type="datetimeFigureOut">
              <a:rPr lang="en-US" smtClean="0"/>
              <a:t>10/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0510F-DB1F-E74A-8057-345FCD244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80563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D12A3-7B8D-7D43-87BF-A776121F7C54}" type="datetimeFigureOut">
              <a:rPr lang="en-US" smtClean="0"/>
              <a:t>10/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0510F-DB1F-E74A-8057-345FCD244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89758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D12A3-7B8D-7D43-87BF-A776121F7C54}" type="datetimeFigureOut">
              <a:rPr lang="en-US" smtClean="0"/>
              <a:t>10/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0510F-DB1F-E74A-8057-345FCD244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67197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D12A3-7B8D-7D43-87BF-A776121F7C54}" type="datetimeFigureOut">
              <a:rPr lang="en-US" smtClean="0"/>
              <a:t>10/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0510F-DB1F-E74A-8057-345FCD244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35121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D12A3-7B8D-7D43-87BF-A776121F7C54}" type="datetimeFigureOut">
              <a:rPr lang="en-US" smtClean="0"/>
              <a:t>10/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0510F-DB1F-E74A-8057-345FCD244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811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D12A3-7B8D-7D43-87BF-A776121F7C54}" type="datetimeFigureOut">
              <a:rPr lang="en-US" smtClean="0"/>
              <a:t>10/5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0510F-DB1F-E74A-8057-345FCD244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62306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D12A3-7B8D-7D43-87BF-A776121F7C54}" type="datetimeFigureOut">
              <a:rPr lang="en-US" smtClean="0"/>
              <a:t>10/5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0510F-DB1F-E74A-8057-345FCD244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19170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D12A3-7B8D-7D43-87BF-A776121F7C54}" type="datetimeFigureOut">
              <a:rPr lang="en-US" smtClean="0"/>
              <a:t>10/5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0510F-DB1F-E74A-8057-345FCD244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88595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D12A3-7B8D-7D43-87BF-A776121F7C54}" type="datetimeFigureOut">
              <a:rPr lang="en-US" smtClean="0"/>
              <a:t>10/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0510F-DB1F-E74A-8057-345FCD244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52014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D12A3-7B8D-7D43-87BF-A776121F7C54}" type="datetimeFigureOut">
              <a:rPr lang="en-US" smtClean="0"/>
              <a:t>10/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0510F-DB1F-E74A-8057-345FCD244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755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AD12A3-7B8D-7D43-87BF-A776121F7C54}" type="datetimeFigureOut">
              <a:rPr lang="en-US" smtClean="0"/>
              <a:t>10/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E0510F-DB1F-E74A-8057-345FCD244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56542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04AF9A8-40AF-7843-B9DB-E5992968169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07694" y="790916"/>
            <a:ext cx="6328611" cy="4121382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D5CDB4F6-6C3E-194B-A83E-67DA9CF2DE13}"/>
              </a:ext>
            </a:extLst>
          </p:cNvPr>
          <p:cNvSpPr txBox="1"/>
          <p:nvPr/>
        </p:nvSpPr>
        <p:spPr>
          <a:xfrm>
            <a:off x="1612232" y="5161549"/>
            <a:ext cx="62443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l Figure 1. </a:t>
            </a:r>
            <a:r>
              <a:rPr lang="en-US" sz="1200" dirty="0"/>
              <a:t>Correlation between fractions of genes expressed per RCC calculated using two different thresholds of expression (≥1 UMI and &gt;1 cell).</a:t>
            </a:r>
          </a:p>
        </p:txBody>
      </p:sp>
    </p:spTree>
    <p:extLst>
      <p:ext uri="{BB962C8B-B14F-4D97-AF65-F5344CB8AC3E}">
        <p14:creationId xmlns:p14="http://schemas.microsoft.com/office/powerpoint/2010/main" val="38301418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EE7CC65E-D76A-924D-9F51-E934B484E5C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91249" y="617283"/>
            <a:ext cx="6117656" cy="413177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E0185C8-AFBA-F141-B765-DF6AF1ACCD7C}"/>
              </a:ext>
            </a:extLst>
          </p:cNvPr>
          <p:cNvSpPr txBox="1"/>
          <p:nvPr/>
        </p:nvSpPr>
        <p:spPr>
          <a:xfrm>
            <a:off x="1513171" y="4800602"/>
            <a:ext cx="61176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l Figure 2.</a:t>
            </a:r>
            <a:r>
              <a:rPr lang="en-US" sz="1200" dirty="0"/>
              <a:t> Correlation between genes expressed per RCC and cells per RCC.</a:t>
            </a:r>
          </a:p>
        </p:txBody>
      </p:sp>
    </p:spTree>
    <p:extLst>
      <p:ext uri="{BB962C8B-B14F-4D97-AF65-F5344CB8AC3E}">
        <p14:creationId xmlns:p14="http://schemas.microsoft.com/office/powerpoint/2010/main" val="42080817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CB26A3AC-FDE6-8B42-86E2-91E1F685F4CC}"/>
              </a:ext>
            </a:extLst>
          </p:cNvPr>
          <p:cNvSpPr/>
          <p:nvPr/>
        </p:nvSpPr>
        <p:spPr>
          <a:xfrm>
            <a:off x="1960108" y="6290283"/>
            <a:ext cx="536608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Supplemental Figure 3.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Distributions of root cell clusters expressed per gene </a:t>
            </a:r>
            <a:r>
              <a:rPr lang="en-US" sz="12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(A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) or gene pair </a:t>
            </a:r>
            <a:r>
              <a:rPr lang="en-US" sz="12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(B)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for each duplication mechanism.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8A2EBC7F-B19D-F944-AE5B-453BD00EBB7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04490" y="31186"/>
            <a:ext cx="4890093" cy="62902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252664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B67E710-5143-0F4F-9AD6-DE39084F3DB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8288" y="730700"/>
            <a:ext cx="8975558" cy="4187048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DC50E023-5F1E-634F-A2EE-FA75046613CD}"/>
              </a:ext>
            </a:extLst>
          </p:cNvPr>
          <p:cNvSpPr/>
          <p:nvPr/>
        </p:nvSpPr>
        <p:spPr>
          <a:xfrm>
            <a:off x="409066" y="4967675"/>
            <a:ext cx="8386007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</a:rPr>
              <a:t>Supplemental Figure 4.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</a:rPr>
              <a:t> Bulk tissue RNA-seq based estimates of expression for Class 1 genes. </a:t>
            </a: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</a:rPr>
              <a:t>(A)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</a:rPr>
              <a:t> Expression breadth (number of SRA libraries out of the 214 libraries examined expressing the gene at ≥ 5 reads). </a:t>
            </a: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</a:rPr>
              <a:t>(B)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</a:rPr>
              <a:t> Expression breadth in non-root tissues (number of SRA libraries out of the 92 non-root tissue containing SRA libraries examined expressing the gene at ≥ 5 reads). </a:t>
            </a: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</a:rPr>
              <a:t>(C)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</a:rPr>
              <a:t> Expression level (combined read count from all 214 SRA libraries). </a:t>
            </a: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</a:rPr>
              <a:t>(D)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</a:rPr>
              <a:t> Expression level in non-root tissues (combined read count from 92 non-root tissue containing SRA libraries). ”Class_1_scA” are the copies of Class 1 gene pairs expressed in the single cell root RCCs. “Class_1_scB” are the paralogues of Class 1 gene pairs not expressed in root RCCs. “Other” is the set of all other nuclear genes in Arabidopsis (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</a:rPr>
              <a:t>Araport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</a:rPr>
              <a:t> 11).</a:t>
            </a:r>
          </a:p>
        </p:txBody>
      </p:sp>
    </p:spTree>
    <p:extLst>
      <p:ext uri="{BB962C8B-B14F-4D97-AF65-F5344CB8AC3E}">
        <p14:creationId xmlns:p14="http://schemas.microsoft.com/office/powerpoint/2010/main" val="247344077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AE36A3D9-3171-C446-BFB1-CB469F079E81}"/>
              </a:ext>
            </a:extLst>
          </p:cNvPr>
          <p:cNvSpPr/>
          <p:nvPr/>
        </p:nvSpPr>
        <p:spPr>
          <a:xfrm>
            <a:off x="986423" y="5132204"/>
            <a:ext cx="7170821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Supplemental Figure </a:t>
            </a: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</a:rPr>
              <a:t>5</a:t>
            </a:r>
            <a:r>
              <a:rPr lang="en-US" sz="12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RCC-u genes are enriched for WGD duplicates. Blue bars and orange bars indicate the fraction of genes that retain duplicates from the indicated mechanism for the whole genome and the RCC-u genes, respectively. The RCC-u gene set has a higher fraction of WGD duplicates and older TEs, and lower fraction of SSDs and singletons, relative to the whole genome.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DC2010F8-73E1-A443-A5CD-3D3F47FAF4E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24508" y="511382"/>
            <a:ext cx="5097857" cy="43373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48046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</TotalTime>
  <Words>305</Words>
  <Application>Microsoft Macintosh PowerPoint</Application>
  <PresentationFormat>Letter Paper (8.5x11 in)</PresentationFormat>
  <Paragraphs>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remy Coate</dc:creator>
  <cp:lastModifiedBy>Jeremy Coate</cp:lastModifiedBy>
  <cp:revision>2</cp:revision>
  <dcterms:created xsi:type="dcterms:W3CDTF">2020-10-05T21:35:59Z</dcterms:created>
  <dcterms:modified xsi:type="dcterms:W3CDTF">2020-10-05T21:48:30Z</dcterms:modified>
</cp:coreProperties>
</file>